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6" d="100"/>
          <a:sy n="76" d="100"/>
        </p:scale>
        <p:origin x="-894" y="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4DAB98-4AE6-4644-8DE4-37D4FCDF7F4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5F66B8-A0CC-47C7-A6B3-7A2271D35F2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81CFDC8-2032-43CC-BAFD-E671A439C66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369AEA-E27B-4E05-B6F3-9CA67F98867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A2850A-964E-4EE6-901F-6820D095F95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737201-F440-41E2-961E-79092F50083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1027965-B959-4346-85B4-483D8B73895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91E6B0-2BCF-4040-BF46-742249427D9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24236C-041B-4C46-95DF-EB00CF19138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F3BED35-3248-40DF-8C9E-F7607DE163E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D9F786-2355-4DEE-9C71-F5B7FBE2BD0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9CCBB857-26AF-4F58-8EB0-D3F52571AC5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Fig 1 supplemental 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7158" y="571480"/>
            <a:ext cx="8429652" cy="59848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28596" y="1142984"/>
            <a:ext cx="8215370" cy="38318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smtClean="0"/>
              <a:t>Figure S1</a:t>
            </a:r>
            <a:r>
              <a:rPr lang="en-US" b="1" dirty="0"/>
              <a:t>. Effects of different target resuscitation pressures on liver and renal function in different ages and sexes of rats after uncontrolled hemorrhagic shock. </a:t>
            </a:r>
            <a:r>
              <a:rPr lang="en-US" dirty="0"/>
              <a:t>Data are mean </a:t>
            </a:r>
            <a:r>
              <a:rPr lang="en-US" altLang="zh-CN" dirty="0"/>
              <a:t>±</a:t>
            </a:r>
            <a:r>
              <a:rPr lang="en-US" dirty="0"/>
              <a:t>SD (n= 8/group). A: changes in </a:t>
            </a:r>
            <a:r>
              <a:rPr lang="en-US" dirty="0" err="1"/>
              <a:t>alanine</a:t>
            </a:r>
            <a:r>
              <a:rPr lang="en-US" dirty="0"/>
              <a:t> </a:t>
            </a:r>
            <a:r>
              <a:rPr lang="en-US" dirty="0" err="1"/>
              <a:t>aminotransferase</a:t>
            </a:r>
            <a:r>
              <a:rPr lang="en-US" dirty="0"/>
              <a:t> (ALT) levels; B: changes in </a:t>
            </a:r>
            <a:r>
              <a:rPr lang="en-US" dirty="0" err="1"/>
              <a:t>aspartate</a:t>
            </a:r>
            <a:r>
              <a:rPr lang="en-US" dirty="0"/>
              <a:t> </a:t>
            </a:r>
            <a:r>
              <a:rPr lang="en-US" dirty="0" err="1"/>
              <a:t>aminotransferase</a:t>
            </a:r>
            <a:r>
              <a:rPr lang="en-US" dirty="0"/>
              <a:t> (AST) level; C: changes in blood urea nitrogen (BUN); D: changes in serum </a:t>
            </a:r>
            <a:r>
              <a:rPr lang="en-US" dirty="0" err="1"/>
              <a:t>creatinine</a:t>
            </a:r>
            <a:r>
              <a:rPr lang="en-US" dirty="0"/>
              <a:t> (</a:t>
            </a:r>
            <a:r>
              <a:rPr lang="en-US" dirty="0" err="1"/>
              <a:t>Scr</a:t>
            </a:r>
            <a:r>
              <a:rPr lang="en-US" dirty="0"/>
              <a:t>). ANOVA analysis showed these parameters had significant changes following hemorrhagic shock and fluid infusion between ages and different target resuscitation pressures(P&lt;0.01), but no significant difference between sexes (P&gt;0.05). #: P&lt;0.05, ##: P&lt;0.01 </a:t>
            </a:r>
            <a:r>
              <a:rPr lang="en-US" i="1" dirty="0" err="1"/>
              <a:t>vs</a:t>
            </a:r>
            <a:r>
              <a:rPr lang="en-US" dirty="0"/>
              <a:t> 40 mmHg group</a:t>
            </a:r>
            <a:r>
              <a:rPr lang="en-US" dirty="0" smtClean="0"/>
              <a:t>.</a:t>
            </a:r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</Words>
  <Application>Microsoft Office PowerPoint</Application>
  <PresentationFormat>On-screen Show (4:3)</PresentationFormat>
  <Paragraphs>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默认设计模板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Chi Yin Chau</cp:lastModifiedBy>
  <cp:revision>9</cp:revision>
  <dcterms:created xsi:type="dcterms:W3CDTF">2013-05-24T02:56:18Z</dcterms:created>
  <dcterms:modified xsi:type="dcterms:W3CDTF">2013-09-10T16:47:01Z</dcterms:modified>
</cp:coreProperties>
</file>